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2" r:id="rId4"/>
    <p:sldId id="263" r:id="rId5"/>
    <p:sldId id="259" r:id="rId6"/>
    <p:sldId id="264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2100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431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612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611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966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017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711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63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301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540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584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850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451E31-5ACB-4B29-B818-DD9297F83CFF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00562-90AE-4A1E-87B8-74894420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688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4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76199" y="17640"/>
            <a:ext cx="294871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dditional file 1: Figure S1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641532" y="685800"/>
            <a:ext cx="3505201" cy="7239000"/>
            <a:chOff x="1641532" y="457200"/>
            <a:chExt cx="3505201" cy="7239000"/>
          </a:xfrm>
        </p:grpSpPr>
        <p:sp>
          <p:nvSpPr>
            <p:cNvPr id="6" name="Rounded Rectangle 5"/>
            <p:cNvSpPr/>
            <p:nvPr/>
          </p:nvSpPr>
          <p:spPr>
            <a:xfrm>
              <a:off x="2109715" y="613954"/>
              <a:ext cx="2590799" cy="716526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15 Homo sapiens microRNAs</a:t>
              </a:r>
            </a:p>
            <a:p>
              <a:pPr algn="ctr"/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Let7a-1 to 499b, </a:t>
              </a:r>
              <a:r>
                <a:rPr lang="en-US" sz="12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RBase</a:t>
              </a: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, GRCh38)</a:t>
              </a:r>
            </a:p>
          </p:txBody>
        </p:sp>
        <p:sp>
          <p:nvSpPr>
            <p:cNvPr id="7" name="Rounded Rectangle 6"/>
            <p:cNvSpPr/>
            <p:nvPr/>
          </p:nvSpPr>
          <p:spPr>
            <a:xfrm>
              <a:off x="2218300" y="1711480"/>
              <a:ext cx="2399113" cy="6858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Kb-5UTR genomic sequence </a:t>
              </a:r>
            </a:p>
            <a:p>
              <a:pPr algn="ctr"/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UCSC Genome Browser) </a:t>
              </a:r>
            </a:p>
          </p:txBody>
        </p:sp>
        <p:sp>
          <p:nvSpPr>
            <p:cNvPr id="8" name="Rounded Rectangle 7"/>
            <p:cNvSpPr/>
            <p:nvPr/>
          </p:nvSpPr>
          <p:spPr>
            <a:xfrm>
              <a:off x="2502672" y="2778280"/>
              <a:ext cx="1809941" cy="6096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pG</a:t>
              </a: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island prediction</a:t>
              </a:r>
            </a:p>
            <a:p>
              <a:pPr algn="ctr"/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thPrimer</a:t>
              </a: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9" name="Down Arrow 8"/>
            <p:cNvSpPr/>
            <p:nvPr/>
          </p:nvSpPr>
          <p:spPr>
            <a:xfrm>
              <a:off x="3272857" y="2447354"/>
              <a:ext cx="277756" cy="291281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Down Arrow 9"/>
            <p:cNvSpPr/>
            <p:nvPr/>
          </p:nvSpPr>
          <p:spPr>
            <a:xfrm>
              <a:off x="3272857" y="1382098"/>
              <a:ext cx="277756" cy="291281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Down Arrow 10"/>
            <p:cNvSpPr/>
            <p:nvPr/>
          </p:nvSpPr>
          <p:spPr>
            <a:xfrm>
              <a:off x="3272857" y="3437954"/>
              <a:ext cx="277756" cy="291281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ounded Rectangle 11"/>
            <p:cNvSpPr/>
            <p:nvPr/>
          </p:nvSpPr>
          <p:spPr>
            <a:xfrm>
              <a:off x="2483813" y="3762120"/>
              <a:ext cx="1905000" cy="6096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6 genomic loci with intense </a:t>
              </a:r>
              <a:r>
                <a:rPr lang="en-US" sz="12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pG</a:t>
              </a: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islands</a:t>
              </a:r>
            </a:p>
          </p:txBody>
        </p:sp>
        <p:sp>
          <p:nvSpPr>
            <p:cNvPr id="13" name="Down Arrow 12"/>
            <p:cNvSpPr/>
            <p:nvPr/>
          </p:nvSpPr>
          <p:spPr>
            <a:xfrm>
              <a:off x="3272857" y="4442073"/>
              <a:ext cx="277756" cy="291281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ounded Rectangle 13"/>
            <p:cNvSpPr/>
            <p:nvPr/>
          </p:nvSpPr>
          <p:spPr>
            <a:xfrm>
              <a:off x="2483813" y="4772835"/>
              <a:ext cx="1809941" cy="6096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reened 22 loci in cell lines </a:t>
              </a:r>
            </a:p>
          </p:txBody>
        </p:sp>
        <p:sp>
          <p:nvSpPr>
            <p:cNvPr id="15" name="Rounded Rectangle 14"/>
            <p:cNvSpPr/>
            <p:nvPr/>
          </p:nvSpPr>
          <p:spPr>
            <a:xfrm>
              <a:off x="2483813" y="5750080"/>
              <a:ext cx="1809941" cy="6096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reened 12 loci in tissues</a:t>
              </a:r>
            </a:p>
          </p:txBody>
        </p:sp>
        <p:sp>
          <p:nvSpPr>
            <p:cNvPr id="16" name="Down Arrow 15"/>
            <p:cNvSpPr/>
            <p:nvPr/>
          </p:nvSpPr>
          <p:spPr>
            <a:xfrm>
              <a:off x="3272857" y="5410200"/>
              <a:ext cx="277756" cy="291281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Down Arrow 16"/>
            <p:cNvSpPr/>
            <p:nvPr/>
          </p:nvSpPr>
          <p:spPr>
            <a:xfrm>
              <a:off x="3272857" y="6414319"/>
              <a:ext cx="277756" cy="291281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203559" y="457200"/>
              <a:ext cx="635049" cy="76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024912" y="7543800"/>
              <a:ext cx="635049" cy="76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/>
            <p:cNvSpPr/>
            <p:nvPr/>
          </p:nvSpPr>
          <p:spPr>
            <a:xfrm flipV="1">
              <a:off x="1641532" y="982979"/>
              <a:ext cx="317525" cy="4571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/>
            <p:cNvSpPr/>
            <p:nvPr/>
          </p:nvSpPr>
          <p:spPr>
            <a:xfrm flipV="1">
              <a:off x="4829208" y="984066"/>
              <a:ext cx="317525" cy="4571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ounded Rectangle 23"/>
            <p:cNvSpPr/>
            <p:nvPr/>
          </p:nvSpPr>
          <p:spPr>
            <a:xfrm>
              <a:off x="2560013" y="6781800"/>
              <a:ext cx="1684591" cy="9144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ven loci as a biomarker panel by ROC analysi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707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9" name="Straight Arrow Connector 28"/>
          <p:cNvCxnSpPr/>
          <p:nvPr/>
        </p:nvCxnSpPr>
        <p:spPr>
          <a:xfrm flipH="1">
            <a:off x="2592685" y="4038601"/>
            <a:ext cx="152400" cy="248435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12" y="405165"/>
            <a:ext cx="1662265" cy="139305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1412" y="400467"/>
            <a:ext cx="1599269" cy="1397753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9950" y="381000"/>
            <a:ext cx="1638062" cy="14015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4212" y="381000"/>
            <a:ext cx="1621543" cy="1417220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12" y="1889479"/>
            <a:ext cx="1638062" cy="1401596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1412" y="1889480"/>
            <a:ext cx="1599269" cy="14015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8386" y="1890265"/>
            <a:ext cx="1641189" cy="140427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3738" y="1889480"/>
            <a:ext cx="1638062" cy="1401596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" y="3352801"/>
            <a:ext cx="1628774" cy="1393649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1412" y="3352801"/>
            <a:ext cx="1599269" cy="1368403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580" y="3352800"/>
            <a:ext cx="1617432" cy="1383945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6632" y="3352801"/>
            <a:ext cx="1645168" cy="1368403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24" y="4794074"/>
            <a:ext cx="1619249" cy="1385499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1887" y="4794073"/>
            <a:ext cx="1619248" cy="1385499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579" y="4794073"/>
            <a:ext cx="1619249" cy="13854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3738" y="4794074"/>
            <a:ext cx="1670761" cy="14001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" y="6248400"/>
            <a:ext cx="1632245" cy="139661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7437" y="6248400"/>
            <a:ext cx="1633698" cy="139786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0105" y="6257926"/>
            <a:ext cx="1607907" cy="139039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7" name="Picture 23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1742" y="6257926"/>
            <a:ext cx="1682757" cy="1390392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8" name="Picture 24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" y="7734301"/>
            <a:ext cx="1628773" cy="139364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9" name="Picture 25"/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7437" y="7724776"/>
            <a:ext cx="1633698" cy="1397862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Rectangle 25"/>
          <p:cNvSpPr/>
          <p:nvPr/>
        </p:nvSpPr>
        <p:spPr>
          <a:xfrm>
            <a:off x="76199" y="17640"/>
            <a:ext cx="464820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dditional file 2: Figure S2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84777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2" y="951025"/>
            <a:ext cx="1738312" cy="1487375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977" y="2617162"/>
            <a:ext cx="1738312" cy="1487375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2617162"/>
            <a:ext cx="1738312" cy="1487375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3401" y="2617161"/>
            <a:ext cx="1738312" cy="1487375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3644" y="4227625"/>
            <a:ext cx="1738312" cy="1487375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7688" y="4210050"/>
            <a:ext cx="1738312" cy="1487375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977" y="5904025"/>
            <a:ext cx="1738312" cy="1487375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962025"/>
            <a:ext cx="1725457" cy="14763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7687" y="5904023"/>
            <a:ext cx="1738313" cy="14873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977" y="4250231"/>
            <a:ext cx="1747837" cy="146476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3644" y="5904025"/>
            <a:ext cx="1738311" cy="148737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4351" y="962025"/>
            <a:ext cx="1757362" cy="14763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Rectangle 14"/>
          <p:cNvSpPr/>
          <p:nvPr/>
        </p:nvSpPr>
        <p:spPr>
          <a:xfrm>
            <a:off x="76199" y="17640"/>
            <a:ext cx="294871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dditional file 4: Figure S3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83437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2D073534-14B7-4C7C-864A-F0944BA61F0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756987" y="902733"/>
            <a:ext cx="5013960" cy="304038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31D6D709-CE1E-4ACE-9FE1-123E8B6D37D1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756987" y="5029200"/>
            <a:ext cx="5013960" cy="304038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A5C59195-72BE-4742-AB26-541521BDE882}"/>
              </a:ext>
            </a:extLst>
          </p:cNvPr>
          <p:cNvSpPr txBox="1"/>
          <p:nvPr/>
        </p:nvSpPr>
        <p:spPr>
          <a:xfrm>
            <a:off x="152400" y="773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95D3838B-4D2C-41CD-B1E7-C8B5BE26BA33}"/>
              </a:ext>
            </a:extLst>
          </p:cNvPr>
          <p:cNvSpPr txBox="1"/>
          <p:nvPr/>
        </p:nvSpPr>
        <p:spPr>
          <a:xfrm>
            <a:off x="152400" y="4953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Rectangle 7"/>
          <p:cNvSpPr/>
          <p:nvPr/>
        </p:nvSpPr>
        <p:spPr>
          <a:xfrm>
            <a:off x="76199" y="17640"/>
            <a:ext cx="294871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dditional file 6: Figure S4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94696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FA8459D6-E232-4FAA-93AE-FAE2C719CF3A}"/>
              </a:ext>
            </a:extLst>
          </p:cNvPr>
          <p:cNvSpPr txBox="1"/>
          <p:nvPr/>
        </p:nvSpPr>
        <p:spPr>
          <a:xfrm>
            <a:off x="152400" y="773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93140299-5DBE-488F-8A5E-A397B0816641}"/>
              </a:ext>
            </a:extLst>
          </p:cNvPr>
          <p:cNvSpPr txBox="1"/>
          <p:nvPr/>
        </p:nvSpPr>
        <p:spPr>
          <a:xfrm>
            <a:off x="152400" y="4953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Rectangle 10"/>
          <p:cNvSpPr/>
          <p:nvPr/>
        </p:nvSpPr>
        <p:spPr>
          <a:xfrm>
            <a:off x="76199" y="17640"/>
            <a:ext cx="294871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dditional file 10: Figure S5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366" y="609600"/>
            <a:ext cx="5943600" cy="37734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11"/>
          <p:cNvPicPr/>
          <p:nvPr/>
        </p:nvPicPr>
        <p:blipFill>
          <a:blip r:embed="rId3"/>
          <a:stretch>
            <a:fillRect/>
          </a:stretch>
        </p:blipFill>
        <p:spPr>
          <a:xfrm>
            <a:off x="507190" y="4456430"/>
            <a:ext cx="5943600" cy="37731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12017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92ADB4E-A15F-4D02-B33A-3A09B04F6184}"/>
              </a:ext>
            </a:extLst>
          </p:cNvPr>
          <p:cNvSpPr txBox="1"/>
          <p:nvPr/>
        </p:nvSpPr>
        <p:spPr>
          <a:xfrm>
            <a:off x="152400" y="773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16F643EA-D304-43DE-B4F1-8643852D9FAD}"/>
              </a:ext>
            </a:extLst>
          </p:cNvPr>
          <p:cNvSpPr txBox="1"/>
          <p:nvPr/>
        </p:nvSpPr>
        <p:spPr>
          <a:xfrm>
            <a:off x="152400" y="4953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Rectangle 6"/>
          <p:cNvSpPr/>
          <p:nvPr/>
        </p:nvSpPr>
        <p:spPr>
          <a:xfrm>
            <a:off x="76199" y="17640"/>
            <a:ext cx="294871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600" b="1" smtClean="0">
                <a:latin typeface="Arial" pitchFamily="34" charset="0"/>
                <a:cs typeface="Arial" pitchFamily="34" charset="0"/>
              </a:rPr>
              <a:t>Additional file 11: </a:t>
            </a: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Figure S6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533400"/>
            <a:ext cx="5943600" cy="37734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7"/>
          <p:cNvPicPr/>
          <p:nvPr/>
        </p:nvPicPr>
        <p:blipFill>
          <a:blip r:embed="rId3"/>
          <a:stretch>
            <a:fillRect/>
          </a:stretch>
        </p:blipFill>
        <p:spPr>
          <a:xfrm>
            <a:off x="503778" y="4953000"/>
            <a:ext cx="5943600" cy="37731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2329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4</TotalTime>
  <Words>97</Words>
  <Application>Microsoft Office PowerPoint</Application>
  <PresentationFormat>On-screen Show (4:3)</PresentationFormat>
  <Paragraphs>22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Colorado Denv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, Shi-Long</dc:creator>
  <cp:lastModifiedBy>Lu, Shi-Long</cp:lastModifiedBy>
  <cp:revision>22</cp:revision>
  <dcterms:created xsi:type="dcterms:W3CDTF">2017-06-14T19:10:18Z</dcterms:created>
  <dcterms:modified xsi:type="dcterms:W3CDTF">2018-02-12T23:02:34Z</dcterms:modified>
</cp:coreProperties>
</file>